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667087" r:id="rId1"/>
    <p:sldMasterId id="2147667111" r:id="rId2"/>
  </p:sldMasterIdLst>
  <p:notesMasterIdLst>
    <p:notesMasterId r:id="rId5"/>
  </p:notesMasterIdLst>
  <p:handoutMasterIdLst>
    <p:handoutMasterId r:id="rId6"/>
  </p:handoutMasterIdLst>
  <p:sldIdLst>
    <p:sldId id="3128" r:id="rId3"/>
    <p:sldId id="3111" r:id="rId4"/>
  </p:sldIdLst>
  <p:sldSz cx="9144000" cy="6858000" type="screen4x3"/>
  <p:notesSz cx="6807200" cy="9939338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5pPr>
    <a:lvl6pPr marL="2286000" algn="l" defTabSz="914400" rtl="0" eaLnBrk="1" latinLnBrk="0" hangingPunct="1"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6pPr>
    <a:lvl7pPr marL="2743200" algn="l" defTabSz="914400" rtl="0" eaLnBrk="1" latinLnBrk="0" hangingPunct="1"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7pPr>
    <a:lvl8pPr marL="3200400" algn="l" defTabSz="914400" rtl="0" eaLnBrk="1" latinLnBrk="0" hangingPunct="1"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8pPr>
    <a:lvl9pPr marL="3657600" algn="l" defTabSz="914400" rtl="0" eaLnBrk="1" latinLnBrk="0" hangingPunct="1">
      <a:defRPr kumimoji="1" sz="4400" b="1" kern="1200">
        <a:solidFill>
          <a:schemeClr val="tx1"/>
        </a:solidFill>
        <a:latin typeface="Times" panose="02020603050405020304" pitchFamily="18" charset="0"/>
        <a:ea typeface="ＭＳ ゴシック" panose="020B0609070205080204" pitchFamily="49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9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>
          <p15:clr>
            <a:srgbClr val="A4A3A4"/>
          </p15:clr>
        </p15:guide>
        <p15:guide id="2" pos="2144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F8F8"/>
    <a:srgbClr val="66FFCC"/>
    <a:srgbClr val="99FF99"/>
    <a:srgbClr val="CCFFCC"/>
    <a:srgbClr val="66FF33"/>
    <a:srgbClr val="9AD35B"/>
    <a:srgbClr val="E4D2CB"/>
    <a:srgbClr val="E5D2CC"/>
    <a:srgbClr val="F2E5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34587" autoAdjust="0"/>
    <p:restoredTop sz="86387" autoAdjust="0"/>
  </p:normalViewPr>
  <p:slideViewPr>
    <p:cSldViewPr>
      <p:cViewPr varScale="1">
        <p:scale>
          <a:sx n="99" d="100"/>
          <a:sy n="99" d="100"/>
        </p:scale>
        <p:origin x="1536" y="78"/>
      </p:cViewPr>
      <p:guideLst>
        <p:guide orient="horz" pos="4319"/>
        <p:guide pos="2880"/>
      </p:guideLst>
    </p:cSldViewPr>
  </p:slideViewPr>
  <p:outlineViewPr>
    <p:cViewPr>
      <p:scale>
        <a:sx n="33" d="100"/>
        <a:sy n="33" d="100"/>
      </p:scale>
      <p:origin x="0" y="-7692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80" d="100"/>
          <a:sy n="80" d="100"/>
        </p:scale>
        <p:origin x="4014" y="102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050" name="Rectangle 2">
            <a:extLst>
              <a:ext uri="{FF2B5EF4-FFF2-40B4-BE49-F238E27FC236}">
                <a16:creationId xmlns:a16="http://schemas.microsoft.com/office/drawing/2014/main" id="{9B963777-CFAE-4A29-96A4-A914FA606FEC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511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14051" name="Rectangle 3">
            <a:extLst>
              <a:ext uri="{FF2B5EF4-FFF2-40B4-BE49-F238E27FC236}">
                <a16:creationId xmlns:a16="http://schemas.microsoft.com/office/drawing/2014/main" id="{643E4221-DBE0-45BB-A1E3-E002250C8539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6038" y="0"/>
            <a:ext cx="29511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14052" name="Rectangle 4">
            <a:extLst>
              <a:ext uri="{FF2B5EF4-FFF2-40B4-BE49-F238E27FC236}">
                <a16:creationId xmlns:a16="http://schemas.microsoft.com/office/drawing/2014/main" id="{3FABB390-8A86-4DDA-9737-3FA6ED8412DA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2450"/>
            <a:ext cx="29511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14053" name="Rectangle 5">
            <a:extLst>
              <a:ext uri="{FF2B5EF4-FFF2-40B4-BE49-F238E27FC236}">
                <a16:creationId xmlns:a16="http://schemas.microsoft.com/office/drawing/2014/main" id="{CBDE8468-B073-4A03-B5A8-3C02191F915A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6038" y="9442450"/>
            <a:ext cx="29511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ea typeface="Osaka" charset="-128"/>
              </a:defRPr>
            </a:lvl1pPr>
          </a:lstStyle>
          <a:p>
            <a:pPr>
              <a:defRPr/>
            </a:pPr>
            <a:fld id="{2AE19353-4A5A-4625-94DB-82ED233E43A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>
            <a:extLst>
              <a:ext uri="{FF2B5EF4-FFF2-40B4-BE49-F238E27FC236}">
                <a16:creationId xmlns:a16="http://schemas.microsoft.com/office/drawing/2014/main" id="{8DC82907-4207-4C7C-B0EC-B12BB66AF63B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511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1" name="Rectangle 3">
            <a:extLst>
              <a:ext uri="{FF2B5EF4-FFF2-40B4-BE49-F238E27FC236}">
                <a16:creationId xmlns:a16="http://schemas.microsoft.com/office/drawing/2014/main" id="{C135F99F-CEF1-47F9-AECC-F8CDBF398CBD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56038" y="0"/>
            <a:ext cx="29511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37924" name="Rectangle 4">
            <a:extLst>
              <a:ext uri="{FF2B5EF4-FFF2-40B4-BE49-F238E27FC236}">
                <a16:creationId xmlns:a16="http://schemas.microsoft.com/office/drawing/2014/main" id="{E9FB5B36-55D8-4EB2-A834-1271D6DF9948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72050" cy="37290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3" name="Rectangle 5">
            <a:extLst>
              <a:ext uri="{FF2B5EF4-FFF2-40B4-BE49-F238E27FC236}">
                <a16:creationId xmlns:a16="http://schemas.microsoft.com/office/drawing/2014/main" id="{0E306A60-5C92-4FE8-B31C-AEF86DFB7479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08050" y="4721225"/>
            <a:ext cx="4991100" cy="447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27654" name="Rectangle 6">
            <a:extLst>
              <a:ext uri="{FF2B5EF4-FFF2-40B4-BE49-F238E27FC236}">
                <a16:creationId xmlns:a16="http://schemas.microsoft.com/office/drawing/2014/main" id="{B410F734-657B-45E8-868D-FDD2011EBD31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42450"/>
            <a:ext cx="29511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b="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5" name="Rectangle 7">
            <a:extLst>
              <a:ext uri="{FF2B5EF4-FFF2-40B4-BE49-F238E27FC236}">
                <a16:creationId xmlns:a16="http://schemas.microsoft.com/office/drawing/2014/main" id="{16A06E03-0981-42FD-943A-CFE81E659988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6038" y="9442450"/>
            <a:ext cx="29511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88" tIns="46094" rIns="92188" bIns="46094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ea typeface="Osaka" charset="-128"/>
              </a:defRPr>
            </a:lvl1pPr>
          </a:lstStyle>
          <a:p>
            <a:pPr>
              <a:defRPr/>
            </a:pPr>
            <a:fld id="{2A1E3B35-566F-4FCC-B2AE-FE31E73C171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2A1E3B35-566F-4FCC-B2AE-FE31E73C1714}" type="slidenum">
              <a:rPr lang="en-US" altLang="ja-JP" smtClean="0"/>
              <a:pPr>
                <a:defRPr/>
              </a:pPr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255277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A1E3B35-566F-4FCC-B2AE-FE31E73C1714}" type="slidenum">
              <a:rPr kumimoji="1" lang="en-US" altLang="ja-JP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" panose="02020603050405020304" pitchFamily="18" charset="0"/>
                <a:ea typeface="Osaka" charset="-128"/>
                <a:cs typeface="+mn-cs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en-US" altLang="ja-JP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" panose="02020603050405020304" pitchFamily="18" charset="0"/>
              <a:ea typeface="Osaka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1590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3E64D-9F3C-47AC-97C6-A28EA8C766C3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3438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EA5FA-A9F8-4572-A34E-67F8BC1BEAF5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0C6F3-C8C6-40D6-9B46-6E3F2D225718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0835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701AB5-321E-4D30-AC3B-D57C0146B9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D86A5EE-2BB7-4DEE-A2B0-A63B43AA23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6D8190-F381-450A-95ED-3B710AC37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F1A012-451A-4504-8326-A8A91C5E3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0CA2E7-8505-42E3-B272-105FC3731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56063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5D28C3-CB6C-48DC-AE45-FAD160AD70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AD687D-8806-4747-8582-755CEE552C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2F5C2D-3522-44B7-B9D5-EC49C9927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28807A-94F9-4032-9591-EF99E40C0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235E09-67A8-430B-8F90-B71B01662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81006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F4C8AE-7286-4B59-BC18-3D37E3A23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AE9C87-9015-4220-8753-1B644B716D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1C2C42-98B5-4FFF-BD04-25BA5CE34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E98826-5C0A-4674-9F01-D210DB45A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EFC7CE-EE21-43BF-87AC-B8FA23715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52744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9EA8F7-20C0-4671-A177-2AA26263E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683BDD-5BE8-4279-ABDD-E16A19959B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21C1160-5D67-415C-8643-261365AAC1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263F258-B792-4E1B-9F3E-BFF43E12C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18116B8-090C-4A4C-8AC9-2F629BD8D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9F620D-4C85-4A61-8BE2-987C3CD3A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68592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5DB7A2-F355-4EB5-BE1F-80CDCD382A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AC2021-2243-4F11-A387-A53C7D6856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8F1F6E0-BE46-4B82-BB2B-2729F491C3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4D12267-5EDC-43AC-AE29-5F27563D84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F9CEB0-13B8-4C83-BA90-FA8BA3F6C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710B6CB-61C5-4E38-920F-045EFA939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28988D3-5D1E-4761-8589-BB38F541A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EE4E2DA-015D-427C-8983-64B413D48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2289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B8646F-6F70-48AD-9583-871D4AFFF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485F26A-50A0-4AEB-9F8A-BA21771DC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D4AF5FF-975F-4E0C-81C5-7543221F6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27ABCE6-8E83-4131-9CF0-EF3FFCA9C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80644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D62147-A095-4CF3-942C-3D0B12140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E40EDCC-6BD6-4E91-BF1F-005EEDABA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745F239-B2E3-4626-8AE2-44611F64D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9796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F0D4B9-459C-4686-8F2D-89FF443F4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B3E2D9-6DFE-4B97-9B1B-ECD57B1E11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DBD720-28E1-4B71-BCAF-B3323FBA6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D29D79-C81A-4E7E-8FA1-633599659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9EDAFB8-0F52-4091-9B2D-F1A0D0073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9E0D6CD-36BE-4DC6-A16C-A9A1407D3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390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F9606-9663-40B9-8D99-F283BB32B9D8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45191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A3F920-0650-44B9-B148-6AC8C9684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C082F51-0ED4-4905-809C-728598D64E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1EE560-B796-432B-8647-D0BE01239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5F17FC-0671-4887-9CFD-86F8075D6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11394B-7CA3-4BC4-B774-D4441EAC2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1B2A302-DFFD-42B4-8EC5-8A98517F6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43404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890B19-98A2-4BC6-9F59-AD328451E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D5D3663-3D82-46C1-AE4C-A8C697A4AF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85D27F-E920-4DA1-B34D-432FF4ABB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9FC4B-5A47-403B-977E-CD03050CA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69673E-07B6-46EC-A195-53F3A90C0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28958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A309014-9D52-4F46-B474-7A9D148295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AB4A94-82F5-4CDE-9996-1060FE0ED8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C8AC5B-55DB-4063-90D2-7A655AA4F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53BD-B86D-4277-8CEC-867A297F4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DA2C2D-896D-471B-9FE2-63896B7D1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700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163BD-9B2E-4F7C-AB47-9EB55D98A96B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047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6EB5-5B68-4BB1-84A5-65A8231F34F4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27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505D7-9846-4642-BF4A-8C6C008B67D5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584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EFBCD-E0EF-4B5A-8A90-95D0AC7B1BEF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315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96576-B085-4FF6-9E08-83D56FEB7B86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218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8853-0140-4E7C-88F1-1852A65C356B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422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9E456-0031-43D3-BA49-D5486932BC88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286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857F9-B2AB-481D-A2FE-F961A440283F}" type="datetime1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665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667088" r:id="rId1"/>
    <p:sldLayoutId id="2147667089" r:id="rId2"/>
    <p:sldLayoutId id="2147667090" r:id="rId3"/>
    <p:sldLayoutId id="2147667091" r:id="rId4"/>
    <p:sldLayoutId id="2147667092" r:id="rId5"/>
    <p:sldLayoutId id="2147667093" r:id="rId6"/>
    <p:sldLayoutId id="2147667094" r:id="rId7"/>
    <p:sldLayoutId id="2147667095" r:id="rId8"/>
    <p:sldLayoutId id="2147667096" r:id="rId9"/>
    <p:sldLayoutId id="2147667097" r:id="rId10"/>
    <p:sldLayoutId id="2147667098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30ABC4-0E12-4D29-B4CD-E78000160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80C403-EA75-4A42-906D-A9BE7E93BF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70FE0D-6068-4B22-AF09-033F2A2429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8188F-D38A-4ECE-BD86-9FCBBA2C1304}" type="datetimeFigureOut">
              <a:rPr kumimoji="1" lang="ja-JP" altLang="en-US" smtClean="0"/>
              <a:t>2021/5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F2DF8C-5B96-4F82-A119-39F83BA5E2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67327A-5DF2-4ED4-990E-73E3DC5373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4BAC5-0C0F-45BC-A328-C1BF28A841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087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667112" r:id="rId1"/>
    <p:sldLayoutId id="2147667113" r:id="rId2"/>
    <p:sldLayoutId id="2147667114" r:id="rId3"/>
    <p:sldLayoutId id="2147667115" r:id="rId4"/>
    <p:sldLayoutId id="2147667116" r:id="rId5"/>
    <p:sldLayoutId id="2147667117" r:id="rId6"/>
    <p:sldLayoutId id="2147667118" r:id="rId7"/>
    <p:sldLayoutId id="2147667119" r:id="rId8"/>
    <p:sldLayoutId id="2147667120" r:id="rId9"/>
    <p:sldLayoutId id="2147667121" r:id="rId10"/>
    <p:sldLayoutId id="214766712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3052F6-79BF-4675-A1B5-0872F20C8593}"/>
              </a:ext>
            </a:extLst>
          </p:cNvPr>
          <p:cNvSpPr txBox="1"/>
          <p:nvPr/>
        </p:nvSpPr>
        <p:spPr>
          <a:xfrm>
            <a:off x="1763688" y="44624"/>
            <a:ext cx="5745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Supplemental Table 1  Patient characteristics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ゴシック" panose="020B0609070205080204" pitchFamily="49" charset="-128"/>
              <a:cs typeface="+mn-cs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D8557FF-BCA4-4362-B100-4E7EC3DDE201}"/>
              </a:ext>
            </a:extLst>
          </p:cNvPr>
          <p:cNvSpPr txBox="1"/>
          <p:nvPr/>
        </p:nvSpPr>
        <p:spPr>
          <a:xfrm>
            <a:off x="467544" y="6253862"/>
            <a:ext cx="832631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ATL, adult T-cell leukemia-lymphoma; ASCT, autologous stem cell transplantation; ECOG PS, Eastern Cooperative Oncology Group performance status;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PBSCT, peripheral blood stem cell transplantation; BMT, bone marrow transplantation; CR, complete remission; PIF, primary induction failure.  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ゴシック" panose="020B0609070205080204" pitchFamily="49" charset="-128"/>
              <a:cs typeface="+mn-cs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6B5E9A7B-0ED3-4B46-88A5-E5784FA210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5316528"/>
              </p:ext>
            </p:extLst>
          </p:nvPr>
        </p:nvGraphicFramePr>
        <p:xfrm>
          <a:off x="539553" y="506288"/>
          <a:ext cx="7992887" cy="5747570"/>
        </p:xfrm>
        <a:graphic>
          <a:graphicData uri="http://schemas.openxmlformats.org/drawingml/2006/table">
            <a:tbl>
              <a:tblPr/>
              <a:tblGrid>
                <a:gridCol w="527970">
                  <a:extLst>
                    <a:ext uri="{9D8B030D-6E8A-4147-A177-3AD203B41FA5}">
                      <a16:colId xmlns:a16="http://schemas.microsoft.com/office/drawing/2014/main" val="2504607912"/>
                    </a:ext>
                  </a:extLst>
                </a:gridCol>
                <a:gridCol w="782178">
                  <a:extLst>
                    <a:ext uri="{9D8B030D-6E8A-4147-A177-3AD203B41FA5}">
                      <a16:colId xmlns:a16="http://schemas.microsoft.com/office/drawing/2014/main" val="2406447109"/>
                    </a:ext>
                  </a:extLst>
                </a:gridCol>
                <a:gridCol w="1036388">
                  <a:extLst>
                    <a:ext uri="{9D8B030D-6E8A-4147-A177-3AD203B41FA5}">
                      <a16:colId xmlns:a16="http://schemas.microsoft.com/office/drawing/2014/main" val="1489233256"/>
                    </a:ext>
                  </a:extLst>
                </a:gridCol>
                <a:gridCol w="997277">
                  <a:extLst>
                    <a:ext uri="{9D8B030D-6E8A-4147-A177-3AD203B41FA5}">
                      <a16:colId xmlns:a16="http://schemas.microsoft.com/office/drawing/2014/main" val="1977603981"/>
                    </a:ext>
                  </a:extLst>
                </a:gridCol>
                <a:gridCol w="1505695">
                  <a:extLst>
                    <a:ext uri="{9D8B030D-6E8A-4147-A177-3AD203B41FA5}">
                      <a16:colId xmlns:a16="http://schemas.microsoft.com/office/drawing/2014/main" val="3988284982"/>
                    </a:ext>
                  </a:extLst>
                </a:gridCol>
                <a:gridCol w="831065">
                  <a:extLst>
                    <a:ext uri="{9D8B030D-6E8A-4147-A177-3AD203B41FA5}">
                      <a16:colId xmlns:a16="http://schemas.microsoft.com/office/drawing/2014/main" val="2588302916"/>
                    </a:ext>
                  </a:extLst>
                </a:gridCol>
                <a:gridCol w="667295">
                  <a:extLst>
                    <a:ext uri="{9D8B030D-6E8A-4147-A177-3AD203B41FA5}">
                      <a16:colId xmlns:a16="http://schemas.microsoft.com/office/drawing/2014/main" val="1142912944"/>
                    </a:ext>
                  </a:extLst>
                </a:gridCol>
                <a:gridCol w="667295">
                  <a:extLst>
                    <a:ext uri="{9D8B030D-6E8A-4147-A177-3AD203B41FA5}">
                      <a16:colId xmlns:a16="http://schemas.microsoft.com/office/drawing/2014/main" val="4255597800"/>
                    </a:ext>
                  </a:extLst>
                </a:gridCol>
                <a:gridCol w="977724">
                  <a:extLst>
                    <a:ext uri="{9D8B030D-6E8A-4147-A177-3AD203B41FA5}">
                      <a16:colId xmlns:a16="http://schemas.microsoft.com/office/drawing/2014/main" val="1545318801"/>
                    </a:ext>
                  </a:extLst>
                </a:gridCol>
              </a:tblGrid>
              <a:tr h="601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ge/Gende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 sub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SCT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Disease status at A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S at A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Survival after A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Survival after diagnosis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ause of death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1285161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2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3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76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8624247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7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1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120950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8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cute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6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6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0190179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2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Relaps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5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52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761643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3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3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10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320517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0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6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4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3211436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1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6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5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861580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3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95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537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279794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9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3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2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85260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3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6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4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3961187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1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8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139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34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982397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2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3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BM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109552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3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9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6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0113725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4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2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2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62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2262155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5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8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cute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34038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6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4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cute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96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0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69130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5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cute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2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29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514186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8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1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1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3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032895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9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2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3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513905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0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3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Relaps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9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2741762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1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1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7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986475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2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0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cute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41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67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776877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3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4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BM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6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23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624711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4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6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Lymphoma typ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15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22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Infectio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912640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4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10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44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1977350"/>
                  </a:ext>
                </a:extLst>
              </a:tr>
              <a:tr h="1903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6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4/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BM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88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TL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095734"/>
                  </a:ext>
                </a:extLst>
              </a:tr>
              <a:tr h="1979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7.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2/M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BSCT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PIF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3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Hemorrhage</a:t>
                      </a:r>
                    </a:p>
                  </a:txBody>
                  <a:tcPr marL="5763" marR="5763" marT="5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1881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2814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561B9F-CF7F-4957-A957-194AA250F9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528" y="44624"/>
            <a:ext cx="8229600" cy="666656"/>
          </a:xfrm>
        </p:spPr>
        <p:txBody>
          <a:bodyPr>
            <a:normAutofit/>
          </a:bodyPr>
          <a:lstStyle/>
          <a:p>
            <a:r>
              <a:rPr kumimoji="1" lang="en-US" altLang="ja-JP" sz="2000" dirty="0"/>
              <a:t>Supplemental Table 2  Characteristics of patients who received </a:t>
            </a:r>
            <a:r>
              <a:rPr lang="en-US" altLang="ja-JP" sz="2000" dirty="0"/>
              <a:t>SCT</a:t>
            </a:r>
            <a:r>
              <a:rPr lang="ja-JP" altLang="en-US" sz="2000" dirty="0"/>
              <a:t> </a:t>
            </a:r>
            <a:r>
              <a:rPr lang="en-US" altLang="ja-JP" sz="2000" dirty="0"/>
              <a:t>twice </a:t>
            </a:r>
            <a:r>
              <a:rPr lang="en-US" altLang="ja-JP" sz="1300" b="1" dirty="0"/>
              <a:t>(n=4)</a:t>
            </a:r>
            <a:endParaRPr kumimoji="1" lang="ja-JP" altLang="en-US" sz="1300" b="1" dirty="0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E95EF4-BA77-4605-926E-FE4365B996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7504" y="883743"/>
            <a:ext cx="8856984" cy="3841398"/>
          </a:xfrm>
        </p:spPr>
        <p:txBody>
          <a:bodyPr>
            <a:normAutofit fontScale="47500" lnSpcReduction="20000"/>
          </a:bodyPr>
          <a:lstStyle/>
          <a:p>
            <a:pPr marL="0" indent="0">
              <a:buNone/>
            </a:pPr>
            <a:r>
              <a:rPr lang="en-US" altLang="ja-JP" dirty="0"/>
              <a:t>No.       Age         Gender    Subtype    SCT type   Source   Disease Status  Outcome  Cause of death    OS after SCT    </a:t>
            </a:r>
          </a:p>
          <a:p>
            <a:pPr marL="0" indent="0">
              <a:buNone/>
            </a:pPr>
            <a:r>
              <a:rPr lang="en-US" altLang="ja-JP" dirty="0"/>
              <a:t>                                                                                                                                                                                      (months)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r>
              <a:rPr lang="en-US" altLang="ja-JP" dirty="0"/>
              <a:t>      at Dx    at SCT     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r>
              <a:rPr lang="en-US" altLang="ja-JP" dirty="0"/>
              <a:t>1.     41        42          F         Unknown       Auto          PB            Relapse                                                                11.7</a:t>
            </a:r>
          </a:p>
          <a:p>
            <a:pPr marL="0" indent="0">
              <a:buNone/>
            </a:pPr>
            <a:r>
              <a:rPr lang="en-US" altLang="ja-JP" dirty="0"/>
              <a:t>1.     41        43          F         Unknown       Auto          PB            Relapse           Dead          Pneumonia              3.4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r>
              <a:rPr lang="en-US" altLang="ja-JP" dirty="0"/>
              <a:t>2.     50        50         M        Unknown       Auto          PB            PIF                                                                          5.6</a:t>
            </a:r>
          </a:p>
          <a:p>
            <a:pPr marL="0" indent="0">
              <a:buNone/>
            </a:pPr>
            <a:r>
              <a:rPr lang="en-US" altLang="ja-JP" dirty="0"/>
              <a:t>2.     50        51         M        Unknown       </a:t>
            </a:r>
            <a:r>
              <a:rPr lang="en-US" altLang="ja-JP" dirty="0" err="1"/>
              <a:t>Allo</a:t>
            </a:r>
            <a:r>
              <a:rPr lang="en-US" altLang="ja-JP" dirty="0"/>
              <a:t>            BM          CR                     Dead          Pneumonia              4.3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r>
              <a:rPr lang="en-US" altLang="ja-JP" dirty="0"/>
              <a:t>3.     30        31          F         Unknown        Auto         PB            PIF                                                                         12.1</a:t>
            </a:r>
          </a:p>
          <a:p>
            <a:pPr marL="0" indent="0">
              <a:buNone/>
            </a:pPr>
            <a:r>
              <a:rPr lang="en-US" altLang="ja-JP" dirty="0"/>
              <a:t>3.     30        31          F         Unknown        </a:t>
            </a:r>
            <a:r>
              <a:rPr lang="en-US" altLang="ja-JP" dirty="0" err="1"/>
              <a:t>Allo</a:t>
            </a:r>
            <a:r>
              <a:rPr lang="en-US" altLang="ja-JP" dirty="0"/>
              <a:t>          BM           PIF                    Dead         Renal failure/ATL    10.9</a:t>
            </a:r>
          </a:p>
          <a:p>
            <a:pPr marL="0" indent="0">
              <a:buNone/>
            </a:pPr>
            <a:r>
              <a:rPr lang="en-US" altLang="ja-JP" dirty="0"/>
              <a:t> </a:t>
            </a:r>
          </a:p>
          <a:p>
            <a:pPr marL="0" indent="0">
              <a:buNone/>
            </a:pPr>
            <a:r>
              <a:rPr lang="en-US" altLang="ja-JP" dirty="0"/>
              <a:t>4.    53        53          M        Lymphoma     Auto         PB            CR                                                                           8.8</a:t>
            </a:r>
          </a:p>
          <a:p>
            <a:pPr marL="0" indent="0">
              <a:buNone/>
            </a:pPr>
            <a:r>
              <a:rPr lang="en-US" altLang="ja-JP" dirty="0"/>
              <a:t>4.    53        54          M        Lymphoma     </a:t>
            </a:r>
            <a:r>
              <a:rPr lang="en-US" altLang="ja-JP" dirty="0" err="1"/>
              <a:t>Allo</a:t>
            </a:r>
            <a:r>
              <a:rPr lang="en-US" altLang="ja-JP" dirty="0"/>
              <a:t>           BM          CR                     Dead         Pneumonitis             5.1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endParaRPr lang="ja-JP" altLang="ja-JP" dirty="0"/>
          </a:p>
          <a:p>
            <a:endParaRPr lang="ja-JP" altLang="ja-JP" dirty="0"/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E8E273F6-1F19-4B1F-BF73-C1E4E0379B8D}"/>
              </a:ext>
            </a:extLst>
          </p:cNvPr>
          <p:cNvCxnSpPr>
            <a:cxnSpLocks/>
          </p:cNvCxnSpPr>
          <p:nvPr/>
        </p:nvCxnSpPr>
        <p:spPr>
          <a:xfrm>
            <a:off x="251520" y="4797152"/>
            <a:ext cx="864096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9EE8D68-5F9D-4B47-A6AB-0F78973E2780}"/>
              </a:ext>
            </a:extLst>
          </p:cNvPr>
          <p:cNvSpPr txBox="1"/>
          <p:nvPr/>
        </p:nvSpPr>
        <p:spPr>
          <a:xfrm>
            <a:off x="611560" y="4941168"/>
            <a:ext cx="500431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SCT, stem cell transplantation; OS, overall survival; Dx, diagnosis;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CR, complete remission; PIF, primary induction failure;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ゴシック" panose="020B0609070205080204" pitchFamily="49" charset="-128"/>
                <a:cs typeface="+mn-cs"/>
              </a:rPr>
              <a:t>BM, bone marrow; PBSC, peripheral blood stem cell.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ゴシック" panose="020B0609070205080204" pitchFamily="49" charset="-128"/>
              <a:cs typeface="+mn-cs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3564F418-2A26-4EDF-9A98-55584E04EA43}"/>
              </a:ext>
            </a:extLst>
          </p:cNvPr>
          <p:cNvCxnSpPr>
            <a:cxnSpLocks/>
          </p:cNvCxnSpPr>
          <p:nvPr/>
        </p:nvCxnSpPr>
        <p:spPr>
          <a:xfrm>
            <a:off x="251520" y="764704"/>
            <a:ext cx="864096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A8DA191A-63FE-4D62-9C45-1F895E7A6179}"/>
              </a:ext>
            </a:extLst>
          </p:cNvPr>
          <p:cNvCxnSpPr>
            <a:cxnSpLocks/>
          </p:cNvCxnSpPr>
          <p:nvPr/>
        </p:nvCxnSpPr>
        <p:spPr>
          <a:xfrm>
            <a:off x="518864" y="1484784"/>
            <a:ext cx="1028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FCBE576D-73B2-48CA-A6AD-0A5DCAFD88BC}"/>
              </a:ext>
            </a:extLst>
          </p:cNvPr>
          <p:cNvCxnSpPr>
            <a:cxnSpLocks/>
          </p:cNvCxnSpPr>
          <p:nvPr/>
        </p:nvCxnSpPr>
        <p:spPr>
          <a:xfrm>
            <a:off x="251520" y="1916832"/>
            <a:ext cx="864096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7576074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acintosh HD:ソフト:Microsoft Office 2001:テンプレート:プレゼンテーション:デザイン:Fireball</Template>
  <TotalTime>15411</TotalTime>
  <Words>585</Words>
  <Application>Microsoft Office PowerPoint</Application>
  <PresentationFormat>画面に合わせる (4:3)</PresentationFormat>
  <Paragraphs>278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Times</vt:lpstr>
      <vt:lpstr>2_Office テーマ</vt:lpstr>
      <vt:lpstr>1_Office テーマ</vt:lpstr>
      <vt:lpstr>PowerPoint プレゼンテーション</vt:lpstr>
      <vt:lpstr>Supplemental Table 2  Characteristics of patients who received SCT twice (n=4)</vt:lpstr>
    </vt:vector>
  </TitlesOfParts>
  <Company>***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***</dc:creator>
  <cp:lastModifiedBy>宇都宮 與</cp:lastModifiedBy>
  <cp:revision>908</cp:revision>
  <cp:lastPrinted>2021-03-12T00:48:44Z</cp:lastPrinted>
  <dcterms:created xsi:type="dcterms:W3CDTF">2006-06-16T07:21:41Z</dcterms:created>
  <dcterms:modified xsi:type="dcterms:W3CDTF">2021-05-11T05:23:32Z</dcterms:modified>
</cp:coreProperties>
</file>